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CBDFC-68B8-4FA8-8DE7-DE7AE7FD5D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B0B9B-E1C7-4DA7-9E05-E37DE3F2D6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52EF2-C2C5-44DF-9825-5CE536F047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60046-3BF8-4B3B-9E86-1843B8B991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BC6D8-605E-42C3-8FED-5236234747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0468E-2A7E-454C-BD7D-2E7589336B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358AD-9312-4204-BFF9-6AE669E29D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F337E-8974-49D8-900D-A04B98F716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5CF22-2019-432B-B097-952A7E4596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E1E88-F24D-466B-85E0-2E995529C6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CBE21-A10C-431C-A03B-0AF54DAFB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9F45E-5AF8-4C20-9A8D-15B6E6F702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4C610E-CB06-4903-892F-40AA318CA27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55840" y="620640"/>
            <a:ext cx="98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SA [1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irtinol [10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525680" y="555480"/>
            <a:ext cx="298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-     +    -     -     +     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525680" y="744480"/>
            <a:ext cx="299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-     -     +    -     - 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582560" y="635040"/>
            <a:ext cx="1160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854440" y="635040"/>
            <a:ext cx="1230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747880" y="339840"/>
            <a:ext cx="180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J21-C3 lacI-lap2</a:t>
            </a:r>
            <a:r>
              <a:rPr b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771200" y="303120"/>
            <a:ext cx="682200" cy="33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J21-C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969000" y="152892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an H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956040" y="110160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4K5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>
            <a:grayscl/>
            <a:lum bright="-6000"/>
          </a:blip>
          <a:srcRect l="9355" t="44702" r="10250" b="5617"/>
          <a:stretch/>
        </p:blipFill>
        <p:spPr>
          <a:xfrm>
            <a:off x="1490760" y="1440000"/>
            <a:ext cx="2423880" cy="368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1" name="" descr=""/>
          <p:cNvPicPr/>
          <p:nvPr/>
        </p:nvPicPr>
        <p:blipFill>
          <a:blip r:embed="rId2"/>
          <a:srcRect l="27597" t="60816" r="3583" b="20651"/>
          <a:stretch/>
        </p:blipFill>
        <p:spPr>
          <a:xfrm>
            <a:off x="1494000" y="1065240"/>
            <a:ext cx="2414520" cy="330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2" name=""/>
          <p:cNvSpPr/>
          <p:nvPr/>
        </p:nvSpPr>
        <p:spPr>
          <a:xfrm>
            <a:off x="246240" y="30636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"/>
          <p:cNvGrpSpPr/>
          <p:nvPr/>
        </p:nvGrpSpPr>
        <p:grpSpPr>
          <a:xfrm>
            <a:off x="952200" y="4030560"/>
            <a:ext cx="1834200" cy="91800"/>
            <a:chOff x="952200" y="4030560"/>
            <a:chExt cx="1834200" cy="91800"/>
          </a:xfrm>
        </p:grpSpPr>
        <p:sp>
          <p:nvSpPr>
            <p:cNvPr id="54" name=""/>
            <p:cNvSpPr/>
            <p:nvPr/>
          </p:nvSpPr>
          <p:spPr>
            <a:xfrm>
              <a:off x="952200" y="4030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396800" y="4030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847520" y="4030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93560" y="4030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742840" y="4030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230400" y="19270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3295800" y="2127240"/>
            <a:ext cx="2268360" cy="1898640"/>
            <a:chOff x="3295800" y="2127240"/>
            <a:chExt cx="2268360" cy="1898640"/>
          </a:xfrm>
        </p:grpSpPr>
        <p:sp>
          <p:nvSpPr>
            <p:cNvPr id="61" name=""/>
            <p:cNvSpPr/>
            <p:nvPr/>
          </p:nvSpPr>
          <p:spPr>
            <a:xfrm>
              <a:off x="3387600" y="3697200"/>
              <a:ext cx="103320" cy="31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838680" y="3274920"/>
              <a:ext cx="100080" cy="739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387600" y="3697200"/>
              <a:ext cx="103320" cy="317520"/>
            </a:xfrm>
            <a:custGeom>
              <a:avLst/>
              <a:gdLst/>
              <a:ahLst/>
              <a:rect l="l" t="t" r="r" b="b"/>
              <a:pathLst>
                <a:path w="65" h="200">
                  <a:moveTo>
                    <a:pt x="0" y="0"/>
                  </a:moveTo>
                  <a:lnTo>
                    <a:pt x="65" y="0"/>
                  </a:lnTo>
                  <a:lnTo>
                    <a:pt x="65" y="200"/>
                  </a:lnTo>
                  <a:lnTo>
                    <a:pt x="0" y="20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838680" y="3274920"/>
              <a:ext cx="100080" cy="739800"/>
            </a:xfrm>
            <a:custGeom>
              <a:avLst/>
              <a:gdLst/>
              <a:ahLst/>
              <a:rect l="l" t="t" r="r" b="b"/>
              <a:pathLst>
                <a:path w="63" h="466">
                  <a:moveTo>
                    <a:pt x="0" y="0"/>
                  </a:moveTo>
                  <a:lnTo>
                    <a:pt x="63" y="0"/>
                  </a:lnTo>
                  <a:lnTo>
                    <a:pt x="63" y="466"/>
                  </a:lnTo>
                  <a:lnTo>
                    <a:pt x="0" y="46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287960" y="3075120"/>
              <a:ext cx="101520" cy="939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738680" y="3416400"/>
              <a:ext cx="98280" cy="598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287960" y="3075120"/>
              <a:ext cx="101520" cy="939600"/>
            </a:xfrm>
            <a:custGeom>
              <a:avLst/>
              <a:gdLst/>
              <a:ahLst/>
              <a:rect l="l" t="t" r="r" b="b"/>
              <a:pathLst>
                <a:path w="64" h="592">
                  <a:moveTo>
                    <a:pt x="0" y="0"/>
                  </a:moveTo>
                  <a:lnTo>
                    <a:pt x="64" y="0"/>
                  </a:lnTo>
                  <a:lnTo>
                    <a:pt x="64" y="592"/>
                  </a:lnTo>
                  <a:lnTo>
                    <a:pt x="0" y="592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738680" y="3416400"/>
              <a:ext cx="98280" cy="598320"/>
            </a:xfrm>
            <a:custGeom>
              <a:avLst/>
              <a:gdLst/>
              <a:ahLst/>
              <a:rect l="l" t="t" r="r" b="b"/>
              <a:pathLst>
                <a:path w="62" h="377">
                  <a:moveTo>
                    <a:pt x="0" y="0"/>
                  </a:moveTo>
                  <a:lnTo>
                    <a:pt x="62" y="0"/>
                  </a:lnTo>
                  <a:lnTo>
                    <a:pt x="62" y="377"/>
                  </a:lnTo>
                  <a:lnTo>
                    <a:pt x="0" y="377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186520" y="3611520"/>
              <a:ext cx="102960" cy="403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490920" y="2324160"/>
              <a:ext cx="98280" cy="1690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186520" y="3611520"/>
              <a:ext cx="102960" cy="403200"/>
            </a:xfrm>
            <a:custGeom>
              <a:avLst/>
              <a:gdLst/>
              <a:ahLst/>
              <a:rect l="l" t="t" r="r" b="b"/>
              <a:pathLst>
                <a:path w="65" h="254">
                  <a:moveTo>
                    <a:pt x="0" y="0"/>
                  </a:moveTo>
                  <a:lnTo>
                    <a:pt x="65" y="0"/>
                  </a:lnTo>
                  <a:lnTo>
                    <a:pt x="65" y="254"/>
                  </a:lnTo>
                  <a:lnTo>
                    <a:pt x="0" y="254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490920" y="2324160"/>
              <a:ext cx="98280" cy="1690560"/>
            </a:xfrm>
            <a:custGeom>
              <a:avLst/>
              <a:gdLst/>
              <a:ahLst/>
              <a:rect l="l" t="t" r="r" b="b"/>
              <a:pathLst>
                <a:path w="62" h="1065">
                  <a:moveTo>
                    <a:pt x="0" y="0"/>
                  </a:moveTo>
                  <a:lnTo>
                    <a:pt x="62" y="0"/>
                  </a:lnTo>
                  <a:lnTo>
                    <a:pt x="62" y="1065"/>
                  </a:lnTo>
                  <a:lnTo>
                    <a:pt x="0" y="106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938760" y="3274920"/>
              <a:ext cx="98280" cy="739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389480" y="3129120"/>
              <a:ext cx="98280" cy="88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938760" y="3274920"/>
              <a:ext cx="98280" cy="739800"/>
            </a:xfrm>
            <a:custGeom>
              <a:avLst/>
              <a:gdLst/>
              <a:ahLst/>
              <a:rect l="l" t="t" r="r" b="b"/>
              <a:pathLst>
                <a:path w="62" h="466">
                  <a:moveTo>
                    <a:pt x="0" y="0"/>
                  </a:moveTo>
                  <a:lnTo>
                    <a:pt x="62" y="0"/>
                  </a:lnTo>
                  <a:lnTo>
                    <a:pt x="62" y="466"/>
                  </a:lnTo>
                  <a:lnTo>
                    <a:pt x="0" y="46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389480" y="3129120"/>
              <a:ext cx="98280" cy="885600"/>
            </a:xfrm>
            <a:custGeom>
              <a:avLst/>
              <a:gdLst/>
              <a:ahLst/>
              <a:rect l="l" t="t" r="r" b="b"/>
              <a:pathLst>
                <a:path w="62" h="558">
                  <a:moveTo>
                    <a:pt x="0" y="0"/>
                  </a:moveTo>
                  <a:lnTo>
                    <a:pt x="62" y="0"/>
                  </a:lnTo>
                  <a:lnTo>
                    <a:pt x="62" y="558"/>
                  </a:lnTo>
                  <a:lnTo>
                    <a:pt x="0" y="55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836960" y="3763800"/>
              <a:ext cx="98640" cy="250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289480" y="3836880"/>
              <a:ext cx="98640" cy="177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836960" y="3763800"/>
              <a:ext cx="98640" cy="250920"/>
            </a:xfrm>
            <a:custGeom>
              <a:avLst/>
              <a:gdLst/>
              <a:ahLst/>
              <a:rect l="l" t="t" r="r" b="b"/>
              <a:pathLst>
                <a:path w="62" h="158">
                  <a:moveTo>
                    <a:pt x="0" y="0"/>
                  </a:moveTo>
                  <a:lnTo>
                    <a:pt x="62" y="0"/>
                  </a:lnTo>
                  <a:lnTo>
                    <a:pt x="62" y="158"/>
                  </a:lnTo>
                  <a:lnTo>
                    <a:pt x="0" y="15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289480" y="3836880"/>
              <a:ext cx="98640" cy="177840"/>
            </a:xfrm>
            <a:custGeom>
              <a:avLst/>
              <a:gdLst/>
              <a:ahLst/>
              <a:rect l="l" t="t" r="r" b="b"/>
              <a:pathLst>
                <a:path w="62" h="112">
                  <a:moveTo>
                    <a:pt x="0" y="0"/>
                  </a:moveTo>
                  <a:lnTo>
                    <a:pt x="62" y="0"/>
                  </a:lnTo>
                  <a:lnTo>
                    <a:pt x="62" y="112"/>
                  </a:lnTo>
                  <a:lnTo>
                    <a:pt x="0" y="112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589200" y="2536920"/>
              <a:ext cx="98640" cy="14778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037040" y="3129120"/>
              <a:ext cx="101520" cy="8856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589200" y="2536920"/>
              <a:ext cx="98640" cy="1477800"/>
            </a:xfrm>
            <a:custGeom>
              <a:avLst/>
              <a:gdLst/>
              <a:ahLst/>
              <a:rect l="l" t="t" r="r" b="b"/>
              <a:pathLst>
                <a:path w="62" h="931">
                  <a:moveTo>
                    <a:pt x="0" y="0"/>
                  </a:moveTo>
                  <a:lnTo>
                    <a:pt x="62" y="0"/>
                  </a:lnTo>
                  <a:lnTo>
                    <a:pt x="62" y="931"/>
                  </a:lnTo>
                  <a:lnTo>
                    <a:pt x="0" y="93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037040" y="3129120"/>
              <a:ext cx="101520" cy="885600"/>
            </a:xfrm>
            <a:custGeom>
              <a:avLst/>
              <a:gdLst/>
              <a:ahLst/>
              <a:rect l="l" t="t" r="r" b="b"/>
              <a:pathLst>
                <a:path w="64" h="558">
                  <a:moveTo>
                    <a:pt x="0" y="0"/>
                  </a:moveTo>
                  <a:lnTo>
                    <a:pt x="64" y="0"/>
                  </a:lnTo>
                  <a:lnTo>
                    <a:pt x="64" y="558"/>
                  </a:lnTo>
                  <a:lnTo>
                    <a:pt x="0" y="55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487760" y="3251160"/>
              <a:ext cx="98640" cy="76356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935600" y="3618000"/>
              <a:ext cx="102960" cy="39672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487760" y="3251160"/>
              <a:ext cx="98640" cy="763560"/>
            </a:xfrm>
            <a:custGeom>
              <a:avLst/>
              <a:gdLst/>
              <a:ahLst/>
              <a:rect l="l" t="t" r="r" b="b"/>
              <a:pathLst>
                <a:path w="62" h="481">
                  <a:moveTo>
                    <a:pt x="0" y="0"/>
                  </a:moveTo>
                  <a:lnTo>
                    <a:pt x="62" y="0"/>
                  </a:lnTo>
                  <a:lnTo>
                    <a:pt x="62" y="481"/>
                  </a:lnTo>
                  <a:lnTo>
                    <a:pt x="0" y="48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935600" y="3618000"/>
              <a:ext cx="102960" cy="396720"/>
            </a:xfrm>
            <a:custGeom>
              <a:avLst/>
              <a:gdLst/>
              <a:ahLst/>
              <a:rect l="l" t="t" r="r" b="b"/>
              <a:pathLst>
                <a:path w="65" h="250">
                  <a:moveTo>
                    <a:pt x="0" y="0"/>
                  </a:moveTo>
                  <a:lnTo>
                    <a:pt x="65" y="0"/>
                  </a:lnTo>
                  <a:lnTo>
                    <a:pt x="65" y="250"/>
                  </a:lnTo>
                  <a:lnTo>
                    <a:pt x="0" y="25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388120" y="3879720"/>
              <a:ext cx="98280" cy="1350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388120" y="3879720"/>
              <a:ext cx="98280" cy="135000"/>
            </a:xfrm>
            <a:custGeom>
              <a:avLst/>
              <a:gdLst/>
              <a:ahLst/>
              <a:rect l="l" t="t" r="r" b="b"/>
              <a:pathLst>
                <a:path w="62" h="85">
                  <a:moveTo>
                    <a:pt x="0" y="0"/>
                  </a:moveTo>
                  <a:lnTo>
                    <a:pt x="62" y="0"/>
                  </a:lnTo>
                  <a:lnTo>
                    <a:pt x="62" y="85"/>
                  </a:lnTo>
                  <a:lnTo>
                    <a:pt x="0" y="8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3311640" y="2188800"/>
              <a:ext cx="1440" cy="1825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H="1">
              <a:off x="3301560" y="4014720"/>
              <a:ext cx="972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H="1">
              <a:off x="3295800" y="370836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301920" y="3867120"/>
              <a:ext cx="14400" cy="144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301920" y="3562200"/>
              <a:ext cx="14400" cy="180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H="1">
              <a:off x="3295800" y="340344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3295800" y="310500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301920" y="3255840"/>
              <a:ext cx="14400" cy="180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298680" y="2529000"/>
              <a:ext cx="14400" cy="144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H="1">
              <a:off x="3295800" y="2798640"/>
              <a:ext cx="93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H="1">
              <a:off x="3298320" y="2189160"/>
              <a:ext cx="9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3311280" y="4011480"/>
              <a:ext cx="22510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31164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763800" y="40147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21164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662360" y="40147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11020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56272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239000" y="2127240"/>
              <a:ext cx="535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TS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"/>
          <p:cNvGrpSpPr/>
          <p:nvPr/>
        </p:nvGrpSpPr>
        <p:grpSpPr>
          <a:xfrm>
            <a:off x="5884920" y="2127240"/>
            <a:ext cx="2271600" cy="1898640"/>
            <a:chOff x="5884920" y="2127240"/>
            <a:chExt cx="2271600" cy="1898640"/>
          </a:xfrm>
        </p:grpSpPr>
        <p:sp>
          <p:nvSpPr>
            <p:cNvPr id="111" name=""/>
            <p:cNvSpPr/>
            <p:nvPr/>
          </p:nvSpPr>
          <p:spPr>
            <a:xfrm>
              <a:off x="5979960" y="3452760"/>
              <a:ext cx="103320" cy="561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6431040" y="3251160"/>
              <a:ext cx="100080" cy="763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979960" y="3452760"/>
              <a:ext cx="103320" cy="561960"/>
            </a:xfrm>
            <a:custGeom>
              <a:avLst/>
              <a:gdLst/>
              <a:ahLst/>
              <a:rect l="l" t="t" r="r" b="b"/>
              <a:pathLst>
                <a:path w="65" h="354">
                  <a:moveTo>
                    <a:pt x="0" y="0"/>
                  </a:moveTo>
                  <a:lnTo>
                    <a:pt x="65" y="0"/>
                  </a:lnTo>
                  <a:lnTo>
                    <a:pt x="65" y="354"/>
                  </a:lnTo>
                  <a:lnTo>
                    <a:pt x="0" y="354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6431040" y="3251160"/>
              <a:ext cx="100080" cy="763560"/>
            </a:xfrm>
            <a:custGeom>
              <a:avLst/>
              <a:gdLst/>
              <a:ahLst/>
              <a:rect l="l" t="t" r="r" b="b"/>
              <a:pathLst>
                <a:path w="63" h="481">
                  <a:moveTo>
                    <a:pt x="0" y="0"/>
                  </a:moveTo>
                  <a:lnTo>
                    <a:pt x="63" y="0"/>
                  </a:lnTo>
                  <a:lnTo>
                    <a:pt x="63" y="481"/>
                  </a:lnTo>
                  <a:lnTo>
                    <a:pt x="0" y="48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6880320" y="3075120"/>
              <a:ext cx="101520" cy="939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7331040" y="3330720"/>
              <a:ext cx="98640" cy="684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6880320" y="3075120"/>
              <a:ext cx="101520" cy="939600"/>
            </a:xfrm>
            <a:custGeom>
              <a:avLst/>
              <a:gdLst/>
              <a:ahLst/>
              <a:rect l="l" t="t" r="r" b="b"/>
              <a:pathLst>
                <a:path w="64" h="592">
                  <a:moveTo>
                    <a:pt x="0" y="0"/>
                  </a:moveTo>
                  <a:lnTo>
                    <a:pt x="64" y="0"/>
                  </a:lnTo>
                  <a:lnTo>
                    <a:pt x="64" y="592"/>
                  </a:lnTo>
                  <a:lnTo>
                    <a:pt x="0" y="592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7331040" y="3330720"/>
              <a:ext cx="98640" cy="684000"/>
            </a:xfrm>
            <a:custGeom>
              <a:avLst/>
              <a:gdLst/>
              <a:ahLst/>
              <a:rect l="l" t="t" r="r" b="b"/>
              <a:pathLst>
                <a:path w="62" h="431">
                  <a:moveTo>
                    <a:pt x="0" y="0"/>
                  </a:moveTo>
                  <a:lnTo>
                    <a:pt x="62" y="0"/>
                  </a:lnTo>
                  <a:lnTo>
                    <a:pt x="62" y="431"/>
                  </a:lnTo>
                  <a:lnTo>
                    <a:pt x="0" y="43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7778880" y="3794040"/>
              <a:ext cx="102960" cy="220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6083280" y="2523960"/>
              <a:ext cx="98280" cy="1490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7778880" y="3794040"/>
              <a:ext cx="102960" cy="220680"/>
            </a:xfrm>
            <a:custGeom>
              <a:avLst/>
              <a:gdLst/>
              <a:ahLst/>
              <a:rect l="l" t="t" r="r" b="b"/>
              <a:pathLst>
                <a:path w="65" h="139">
                  <a:moveTo>
                    <a:pt x="0" y="0"/>
                  </a:moveTo>
                  <a:lnTo>
                    <a:pt x="65" y="0"/>
                  </a:lnTo>
                  <a:lnTo>
                    <a:pt x="65" y="139"/>
                  </a:lnTo>
                  <a:lnTo>
                    <a:pt x="0" y="139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6083280" y="2523960"/>
              <a:ext cx="98280" cy="1490760"/>
            </a:xfrm>
            <a:custGeom>
              <a:avLst/>
              <a:gdLst/>
              <a:ahLst/>
              <a:rect l="l" t="t" r="r" b="b"/>
              <a:pathLst>
                <a:path w="62" h="939">
                  <a:moveTo>
                    <a:pt x="0" y="0"/>
                  </a:moveTo>
                  <a:lnTo>
                    <a:pt x="62" y="0"/>
                  </a:lnTo>
                  <a:lnTo>
                    <a:pt x="62" y="939"/>
                  </a:lnTo>
                  <a:lnTo>
                    <a:pt x="0" y="939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6531120" y="2927520"/>
              <a:ext cx="98280" cy="1087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981840" y="3238560"/>
              <a:ext cx="98280" cy="776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6531120" y="2927520"/>
              <a:ext cx="98280" cy="1087200"/>
            </a:xfrm>
            <a:custGeom>
              <a:avLst/>
              <a:gdLst/>
              <a:ahLst/>
              <a:rect l="l" t="t" r="r" b="b"/>
              <a:pathLst>
                <a:path w="62" h="685">
                  <a:moveTo>
                    <a:pt x="0" y="0"/>
                  </a:moveTo>
                  <a:lnTo>
                    <a:pt x="62" y="0"/>
                  </a:lnTo>
                  <a:lnTo>
                    <a:pt x="62" y="685"/>
                  </a:lnTo>
                  <a:lnTo>
                    <a:pt x="0" y="68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981840" y="3238560"/>
              <a:ext cx="98280" cy="776160"/>
            </a:xfrm>
            <a:custGeom>
              <a:avLst/>
              <a:gdLst/>
              <a:ahLst/>
              <a:rect l="l" t="t" r="r" b="b"/>
              <a:pathLst>
                <a:path w="62" h="489">
                  <a:moveTo>
                    <a:pt x="0" y="0"/>
                  </a:moveTo>
                  <a:lnTo>
                    <a:pt x="62" y="0"/>
                  </a:lnTo>
                  <a:lnTo>
                    <a:pt x="62" y="489"/>
                  </a:lnTo>
                  <a:lnTo>
                    <a:pt x="0" y="489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429680" y="3763800"/>
              <a:ext cx="98280" cy="250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881840" y="3830760"/>
              <a:ext cx="98640" cy="1839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429680" y="3763800"/>
              <a:ext cx="98280" cy="250920"/>
            </a:xfrm>
            <a:custGeom>
              <a:avLst/>
              <a:gdLst/>
              <a:ahLst/>
              <a:rect l="l" t="t" r="r" b="b"/>
              <a:pathLst>
                <a:path w="62" h="158">
                  <a:moveTo>
                    <a:pt x="0" y="0"/>
                  </a:moveTo>
                  <a:lnTo>
                    <a:pt x="62" y="0"/>
                  </a:lnTo>
                  <a:lnTo>
                    <a:pt x="62" y="158"/>
                  </a:lnTo>
                  <a:lnTo>
                    <a:pt x="0" y="15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881840" y="3830760"/>
              <a:ext cx="98640" cy="183960"/>
            </a:xfrm>
            <a:custGeom>
              <a:avLst/>
              <a:gdLst/>
              <a:ahLst/>
              <a:rect l="l" t="t" r="r" b="b"/>
              <a:pathLst>
                <a:path w="62" h="116">
                  <a:moveTo>
                    <a:pt x="0" y="0"/>
                  </a:moveTo>
                  <a:lnTo>
                    <a:pt x="62" y="0"/>
                  </a:lnTo>
                  <a:lnTo>
                    <a:pt x="62" y="116"/>
                  </a:lnTo>
                  <a:lnTo>
                    <a:pt x="0" y="11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6181560" y="2665440"/>
              <a:ext cx="98640" cy="134928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6629400" y="2946240"/>
              <a:ext cx="101520" cy="106848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181560" y="2665440"/>
              <a:ext cx="98640" cy="1349280"/>
            </a:xfrm>
            <a:custGeom>
              <a:avLst/>
              <a:gdLst/>
              <a:ahLst/>
              <a:rect l="l" t="t" r="r" b="b"/>
              <a:pathLst>
                <a:path w="62" h="850">
                  <a:moveTo>
                    <a:pt x="0" y="0"/>
                  </a:moveTo>
                  <a:lnTo>
                    <a:pt x="62" y="0"/>
                  </a:lnTo>
                  <a:lnTo>
                    <a:pt x="62" y="850"/>
                  </a:lnTo>
                  <a:lnTo>
                    <a:pt x="0" y="85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6629400" y="2946240"/>
              <a:ext cx="101520" cy="1068480"/>
            </a:xfrm>
            <a:custGeom>
              <a:avLst/>
              <a:gdLst/>
              <a:ahLst/>
              <a:rect l="l" t="t" r="r" b="b"/>
              <a:pathLst>
                <a:path w="64" h="673">
                  <a:moveTo>
                    <a:pt x="0" y="0"/>
                  </a:moveTo>
                  <a:lnTo>
                    <a:pt x="64" y="0"/>
                  </a:lnTo>
                  <a:lnTo>
                    <a:pt x="64" y="673"/>
                  </a:lnTo>
                  <a:lnTo>
                    <a:pt x="0" y="673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7080120" y="3195720"/>
              <a:ext cx="98640" cy="8190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7527960" y="3819600"/>
              <a:ext cx="103320" cy="19512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7080120" y="3195720"/>
              <a:ext cx="98640" cy="819000"/>
            </a:xfrm>
            <a:custGeom>
              <a:avLst/>
              <a:gdLst/>
              <a:ahLst/>
              <a:rect l="l" t="t" r="r" b="b"/>
              <a:pathLst>
                <a:path w="62" h="516">
                  <a:moveTo>
                    <a:pt x="0" y="0"/>
                  </a:moveTo>
                  <a:lnTo>
                    <a:pt x="62" y="0"/>
                  </a:lnTo>
                  <a:lnTo>
                    <a:pt x="62" y="516"/>
                  </a:lnTo>
                  <a:lnTo>
                    <a:pt x="0" y="51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7527960" y="3819600"/>
              <a:ext cx="103320" cy="195120"/>
            </a:xfrm>
            <a:custGeom>
              <a:avLst/>
              <a:gdLst/>
              <a:ahLst/>
              <a:rect l="l" t="t" r="r" b="b"/>
              <a:pathLst>
                <a:path w="65" h="123">
                  <a:moveTo>
                    <a:pt x="0" y="0"/>
                  </a:moveTo>
                  <a:lnTo>
                    <a:pt x="65" y="0"/>
                  </a:lnTo>
                  <a:lnTo>
                    <a:pt x="65" y="123"/>
                  </a:lnTo>
                  <a:lnTo>
                    <a:pt x="0" y="123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7980480" y="3745080"/>
              <a:ext cx="98280" cy="26964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7980480" y="3745080"/>
              <a:ext cx="98280" cy="269640"/>
            </a:xfrm>
            <a:custGeom>
              <a:avLst/>
              <a:gdLst/>
              <a:ahLst/>
              <a:rect l="l" t="t" r="r" b="b"/>
              <a:pathLst>
                <a:path w="62" h="170">
                  <a:moveTo>
                    <a:pt x="0" y="0"/>
                  </a:moveTo>
                  <a:lnTo>
                    <a:pt x="62" y="0"/>
                  </a:lnTo>
                  <a:lnTo>
                    <a:pt x="62" y="170"/>
                  </a:lnTo>
                  <a:lnTo>
                    <a:pt x="0" y="17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5904000" y="2188800"/>
              <a:ext cx="1440" cy="1825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H="1">
              <a:off x="5893920" y="4014720"/>
              <a:ext cx="972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H="1">
              <a:off x="5888160" y="370836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891040" y="3867120"/>
              <a:ext cx="14400" cy="144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894280" y="3562200"/>
              <a:ext cx="14400" cy="180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H="1">
              <a:off x="5888160" y="340344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H="1">
              <a:off x="5888160" y="310500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H="1">
              <a:off x="5884920" y="2798640"/>
              <a:ext cx="9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H="1">
              <a:off x="5884920" y="2494080"/>
              <a:ext cx="9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894280" y="2612880"/>
              <a:ext cx="14400" cy="180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H="1">
              <a:off x="5884920" y="2189160"/>
              <a:ext cx="9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H="1">
              <a:off x="5903640" y="4014720"/>
              <a:ext cx="22510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590400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635652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680400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7254720" y="40147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770256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8155080" y="40147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6757920" y="2127240"/>
              <a:ext cx="776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sirtin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0" name=""/>
            <p:cNvGrpSpPr/>
            <p:nvPr/>
          </p:nvGrpSpPr>
          <p:grpSpPr>
            <a:xfrm>
              <a:off x="7512120" y="2486160"/>
              <a:ext cx="643320" cy="392400"/>
              <a:chOff x="7512120" y="2486160"/>
              <a:chExt cx="643320" cy="392400"/>
            </a:xfrm>
          </p:grpSpPr>
          <p:sp>
            <p:nvSpPr>
              <p:cNvPr id="161" name=""/>
              <p:cNvSpPr/>
              <p:nvPr/>
            </p:nvSpPr>
            <p:spPr>
              <a:xfrm>
                <a:off x="7623000" y="2486160"/>
                <a:ext cx="5324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Arial"/>
                  </a:rPr>
                  <a:t>untagged ba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7622280" y="2620800"/>
                <a:ext cx="4352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Arial"/>
                  </a:rPr>
                  <a:t>tagged ba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3" name=""/>
              <p:cNvGrpSpPr/>
              <p:nvPr/>
            </p:nvGrpSpPr>
            <p:grpSpPr>
              <a:xfrm>
                <a:off x="7512120" y="2511360"/>
                <a:ext cx="55080" cy="335520"/>
                <a:chOff x="7512120" y="2511360"/>
                <a:chExt cx="55080" cy="335520"/>
              </a:xfrm>
            </p:grpSpPr>
            <p:sp>
              <p:nvSpPr>
                <p:cNvPr id="164" name=""/>
                <p:cNvSpPr/>
                <p:nvPr/>
              </p:nvSpPr>
              <p:spPr>
                <a:xfrm>
                  <a:off x="7512120" y="2511360"/>
                  <a:ext cx="55080" cy="536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840" bIns="6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7512120" y="2650680"/>
                  <a:ext cx="55080" cy="56160"/>
                </a:xfrm>
                <a:prstGeom prst="rect">
                  <a:avLst/>
                </a:prstGeom>
                <a:solidFill>
                  <a:srgbClr val="000000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360" bIns="9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>
                  <a:off x="7512120" y="2790360"/>
                  <a:ext cx="55080" cy="56520"/>
                </a:xfrm>
                <a:prstGeom prst="rect">
                  <a:avLst/>
                </a:prstGeom>
                <a:solidFill>
                  <a:srgbClr val="dd0806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720" bIns="9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7" name=""/>
              <p:cNvSpPr/>
              <p:nvPr/>
            </p:nvSpPr>
            <p:spPr>
              <a:xfrm>
                <a:off x="7620120" y="2771640"/>
                <a:ext cx="182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Arial"/>
                  </a:rPr>
                  <a:t>lacO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8" name=""/>
          <p:cNvGrpSpPr/>
          <p:nvPr/>
        </p:nvGrpSpPr>
        <p:grpSpPr>
          <a:xfrm>
            <a:off x="3287880" y="4157640"/>
            <a:ext cx="2246040" cy="1822320"/>
            <a:chOff x="3287880" y="4157640"/>
            <a:chExt cx="2246040" cy="1822320"/>
          </a:xfrm>
        </p:grpSpPr>
        <p:sp>
          <p:nvSpPr>
            <p:cNvPr id="169" name=""/>
            <p:cNvSpPr/>
            <p:nvPr/>
          </p:nvSpPr>
          <p:spPr>
            <a:xfrm>
              <a:off x="3301920" y="4471920"/>
              <a:ext cx="14400" cy="180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301920" y="4172040"/>
              <a:ext cx="14400" cy="144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3381480" y="5759280"/>
              <a:ext cx="104760" cy="2080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3382920" y="5761080"/>
              <a:ext cx="100080" cy="2030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3827520" y="5896080"/>
              <a:ext cx="102960" cy="712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3828960" y="5897520"/>
              <a:ext cx="100080" cy="6660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4273560" y="5678640"/>
              <a:ext cx="103320" cy="28872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4275000" y="5680080"/>
              <a:ext cx="100080" cy="2840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4719600" y="4986360"/>
              <a:ext cx="103320" cy="9810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721400" y="4987800"/>
              <a:ext cx="99720" cy="97632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164200" y="4978440"/>
              <a:ext cx="104760" cy="98892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167440" y="4979880"/>
              <a:ext cx="99720" cy="9842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3479760" y="4816440"/>
              <a:ext cx="104760" cy="115092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3481560" y="4819680"/>
              <a:ext cx="101520" cy="11444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3925800" y="5083200"/>
              <a:ext cx="104760" cy="8841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3927600" y="5086440"/>
              <a:ext cx="101520" cy="87768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371840" y="5386320"/>
              <a:ext cx="104760" cy="5810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373640" y="5388120"/>
              <a:ext cx="101520" cy="57600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818240" y="5575320"/>
              <a:ext cx="104760" cy="3920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819680" y="5578560"/>
              <a:ext cx="101520" cy="38556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264280" y="5564160"/>
              <a:ext cx="104760" cy="4032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265720" y="5565600"/>
              <a:ext cx="101520" cy="39852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579840" y="4816440"/>
              <a:ext cx="103320" cy="115092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3581280" y="4819680"/>
              <a:ext cx="100080" cy="11444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025880" y="5083200"/>
              <a:ext cx="103320" cy="8841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027320" y="5086440"/>
              <a:ext cx="100080" cy="87768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471920" y="5443560"/>
              <a:ext cx="103320" cy="5238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473720" y="5446800"/>
              <a:ext cx="99720" cy="51732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916520" y="5526000"/>
              <a:ext cx="104760" cy="4413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4919760" y="5529240"/>
              <a:ext cx="100080" cy="43488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362560" y="5564160"/>
              <a:ext cx="104760" cy="4032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365800" y="5565600"/>
              <a:ext cx="100080" cy="39852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3376440" y="5754600"/>
              <a:ext cx="98640" cy="209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3379680" y="5757840"/>
              <a:ext cx="92160" cy="2034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822840" y="5889600"/>
              <a:ext cx="98280" cy="74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825720" y="5892840"/>
              <a:ext cx="92160" cy="684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268880" y="5672160"/>
              <a:ext cx="98280" cy="291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272120" y="5675400"/>
              <a:ext cx="91800" cy="2858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714920" y="4979880"/>
              <a:ext cx="98280" cy="984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718160" y="4983120"/>
              <a:ext cx="91800" cy="9781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159520" y="4973760"/>
              <a:ext cx="99720" cy="990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5162400" y="4976640"/>
              <a:ext cx="93960" cy="9846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3475080" y="4811760"/>
              <a:ext cx="100080" cy="1152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478320" y="4815000"/>
              <a:ext cx="93600" cy="11462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3921120" y="5078520"/>
              <a:ext cx="100080" cy="88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924360" y="5081760"/>
              <a:ext cx="93600" cy="8794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367160" y="5381640"/>
              <a:ext cx="100080" cy="582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370400" y="5384880"/>
              <a:ext cx="93600" cy="57636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813200" y="5570640"/>
              <a:ext cx="98640" cy="393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816440" y="5573880"/>
              <a:ext cx="92160" cy="38736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259240" y="5559480"/>
              <a:ext cx="98640" cy="404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262480" y="5562720"/>
              <a:ext cx="92160" cy="3985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3575160" y="4811760"/>
              <a:ext cx="98280" cy="115236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578400" y="4815000"/>
              <a:ext cx="91800" cy="11462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021200" y="5078520"/>
              <a:ext cx="98280" cy="8856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4024440" y="5081760"/>
              <a:ext cx="91800" cy="8794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4467240" y="5438880"/>
              <a:ext cx="98280" cy="52524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470480" y="5442120"/>
              <a:ext cx="92160" cy="5191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911840" y="5521320"/>
              <a:ext cx="99720" cy="4428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915080" y="5524560"/>
              <a:ext cx="93600" cy="4366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357880" y="5559480"/>
              <a:ext cx="100080" cy="40464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361120" y="5562720"/>
              <a:ext cx="93600" cy="3985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3301920" y="4157640"/>
              <a:ext cx="1800" cy="1806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287880" y="5964120"/>
              <a:ext cx="140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287880" y="5664240"/>
              <a:ext cx="140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287880" y="5362560"/>
              <a:ext cx="140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3287880" y="5060880"/>
              <a:ext cx="140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287880" y="4761000"/>
              <a:ext cx="140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3287880" y="4459320"/>
              <a:ext cx="140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287880" y="4157640"/>
              <a:ext cx="140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301920" y="5964120"/>
              <a:ext cx="22305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3301920" y="5964120"/>
              <a:ext cx="180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3747960" y="5964120"/>
              <a:ext cx="180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4194000" y="5964120"/>
              <a:ext cx="180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4640400" y="596412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5086440" y="596412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5532480" y="596412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6" name=""/>
          <p:cNvGrpSpPr/>
          <p:nvPr/>
        </p:nvGrpSpPr>
        <p:grpSpPr>
          <a:xfrm>
            <a:off x="5865840" y="4146480"/>
            <a:ext cx="2268360" cy="1839960"/>
            <a:chOff x="5865840" y="4146480"/>
            <a:chExt cx="2268360" cy="1839960"/>
          </a:xfrm>
        </p:grpSpPr>
        <p:sp>
          <p:nvSpPr>
            <p:cNvPr id="247" name=""/>
            <p:cNvSpPr/>
            <p:nvPr/>
          </p:nvSpPr>
          <p:spPr>
            <a:xfrm>
              <a:off x="5894280" y="4471920"/>
              <a:ext cx="14400" cy="180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5894280" y="4172040"/>
              <a:ext cx="14400" cy="1440"/>
            </a:xfrm>
            <a:custGeom>
              <a:avLst/>
              <a:gdLst/>
              <a:ahLst/>
              <a:rect l="l" t="t" r="r" b="b"/>
              <a:pathLst>
                <a:path w="9" h="0">
                  <a:moveTo>
                    <a:pt x="0" y="0"/>
                  </a:moveTo>
                  <a:lnTo>
                    <a:pt x="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5961240" y="5667480"/>
              <a:ext cx="106200" cy="3063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5964120" y="5668920"/>
              <a:ext cx="100080" cy="30168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411960" y="5621400"/>
              <a:ext cx="104760" cy="3524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6413400" y="5624640"/>
              <a:ext cx="101880" cy="34596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6861240" y="5457960"/>
              <a:ext cx="106200" cy="5158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6864480" y="5460840"/>
              <a:ext cx="99720" cy="50976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7311960" y="5315040"/>
              <a:ext cx="104760" cy="6588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7313760" y="5316480"/>
              <a:ext cx="101520" cy="65412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7761240" y="5040360"/>
              <a:ext cx="106560" cy="9334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7764480" y="5041800"/>
              <a:ext cx="100080" cy="92880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6060960" y="4944960"/>
              <a:ext cx="106560" cy="10288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6062760" y="4946760"/>
              <a:ext cx="102960" cy="10238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6512040" y="4846680"/>
              <a:ext cx="104760" cy="11271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6513480" y="4848120"/>
              <a:ext cx="101520" cy="112248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6961320" y="5402160"/>
              <a:ext cx="106200" cy="5716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6962760" y="5403960"/>
              <a:ext cx="103320" cy="5666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7412040" y="5619600"/>
              <a:ext cx="106200" cy="3542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7413480" y="5621400"/>
              <a:ext cx="101880" cy="34920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7861320" y="5648400"/>
              <a:ext cx="106200" cy="3254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7864560" y="5649840"/>
              <a:ext cx="101520" cy="32076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6161040" y="4635360"/>
              <a:ext cx="106560" cy="133848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6164280" y="4638600"/>
              <a:ext cx="100080" cy="133200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6611760" y="5057640"/>
              <a:ext cx="105120" cy="91620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6613560" y="5059440"/>
              <a:ext cx="101520" cy="91116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7061040" y="5343480"/>
              <a:ext cx="106560" cy="63036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7064280" y="5346720"/>
              <a:ext cx="100080" cy="62388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7512120" y="5670720"/>
              <a:ext cx="104760" cy="30312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7513560" y="5672160"/>
              <a:ext cx="101520" cy="29844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7962840" y="5648400"/>
              <a:ext cx="104760" cy="3254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7964640" y="5649840"/>
              <a:ext cx="99720" cy="320760"/>
            </a:xfrm>
            <a:prstGeom prst="rect">
              <a:avLst/>
            </a:prstGeom>
            <a:noFill/>
            <a:ln w="792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5956200" y="5661000"/>
              <a:ext cx="100080" cy="309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5959440" y="5664240"/>
              <a:ext cx="93600" cy="3031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6407280" y="5616720"/>
              <a:ext cx="98280" cy="353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6410160" y="5619600"/>
              <a:ext cx="92160" cy="34776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6856560" y="5452920"/>
              <a:ext cx="99720" cy="517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6859440" y="5456160"/>
              <a:ext cx="93960" cy="5112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7307280" y="5308560"/>
              <a:ext cx="100080" cy="662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7310520" y="5311800"/>
              <a:ext cx="93600" cy="65556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7756560" y="5033880"/>
              <a:ext cx="100080" cy="936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7759800" y="5037120"/>
              <a:ext cx="93600" cy="9302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6056280" y="4940280"/>
              <a:ext cx="100080" cy="1030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6059520" y="4943520"/>
              <a:ext cx="93600" cy="10238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6505560" y="4840200"/>
              <a:ext cx="101520" cy="1130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6508800" y="4843440"/>
              <a:ext cx="95040" cy="11239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6956280" y="5396040"/>
              <a:ext cx="100080" cy="574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6959520" y="5398920"/>
              <a:ext cx="93600" cy="5684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7407360" y="5614920"/>
              <a:ext cx="100080" cy="355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7410600" y="5618160"/>
              <a:ext cx="93600" cy="3492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7856640" y="5641920"/>
              <a:ext cx="100080" cy="328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7859880" y="5645160"/>
              <a:ext cx="93600" cy="3222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6156360" y="4630680"/>
              <a:ext cx="100080" cy="133992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6159600" y="4633920"/>
              <a:ext cx="93600" cy="133344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6607080" y="5052960"/>
              <a:ext cx="100080" cy="91764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6610320" y="5056200"/>
              <a:ext cx="93600" cy="91116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7056360" y="5338800"/>
              <a:ext cx="100080" cy="63180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7059600" y="5342040"/>
              <a:ext cx="93600" cy="62532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7507440" y="5664240"/>
              <a:ext cx="99720" cy="30636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7510320" y="5667480"/>
              <a:ext cx="93960" cy="29988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7956720" y="5641920"/>
              <a:ext cx="99720" cy="328680"/>
            </a:xfrm>
            <a:prstGeom prst="rect">
              <a:avLst/>
            </a:pr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7959600" y="5645160"/>
              <a:ext cx="93960" cy="3222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5881680" y="4146480"/>
              <a:ext cx="1440" cy="1824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5865840" y="5970600"/>
              <a:ext cx="158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5865840" y="5667480"/>
              <a:ext cx="158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5865840" y="5362560"/>
              <a:ext cx="158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5865840" y="5059440"/>
              <a:ext cx="158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5865840" y="4754520"/>
              <a:ext cx="158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5865840" y="4451400"/>
              <a:ext cx="158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865840" y="4146480"/>
              <a:ext cx="158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5881680" y="5970600"/>
              <a:ext cx="225108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flipV="1">
              <a:off x="5881680" y="597060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V="1">
              <a:off x="6332400" y="5970600"/>
              <a:ext cx="180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flipV="1">
              <a:off x="6781680" y="5970600"/>
              <a:ext cx="180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V="1">
              <a:off x="7232760" y="597060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 flipV="1">
              <a:off x="7682040" y="597060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 flipV="1">
              <a:off x="8132760" y="5970600"/>
              <a:ext cx="1440" cy="15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4" name=""/>
          <p:cNvGrpSpPr/>
          <p:nvPr/>
        </p:nvGrpSpPr>
        <p:grpSpPr>
          <a:xfrm>
            <a:off x="342720" y="2127240"/>
            <a:ext cx="2632320" cy="1941120"/>
            <a:chOff x="342720" y="2127240"/>
            <a:chExt cx="2632320" cy="1941120"/>
          </a:xfrm>
        </p:grpSpPr>
        <p:sp>
          <p:nvSpPr>
            <p:cNvPr id="325" name=""/>
            <p:cNvSpPr/>
            <p:nvPr/>
          </p:nvSpPr>
          <p:spPr>
            <a:xfrm>
              <a:off x="808200" y="3789360"/>
              <a:ext cx="102960" cy="2127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1258920" y="3114720"/>
              <a:ext cx="96840" cy="8874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808200" y="3789360"/>
              <a:ext cx="102960" cy="212760"/>
            </a:xfrm>
            <a:custGeom>
              <a:avLst/>
              <a:gdLst/>
              <a:ahLst/>
              <a:rect l="l" t="t" r="r" b="b"/>
              <a:pathLst>
                <a:path w="65" h="134">
                  <a:moveTo>
                    <a:pt x="0" y="0"/>
                  </a:moveTo>
                  <a:lnTo>
                    <a:pt x="65" y="0"/>
                  </a:lnTo>
                  <a:lnTo>
                    <a:pt x="65" y="134"/>
                  </a:lnTo>
                  <a:lnTo>
                    <a:pt x="0" y="134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258920" y="3114720"/>
              <a:ext cx="96840" cy="887400"/>
            </a:xfrm>
            <a:custGeom>
              <a:avLst/>
              <a:gdLst/>
              <a:ahLst/>
              <a:rect l="l" t="t" r="r" b="b"/>
              <a:pathLst>
                <a:path w="61" h="559">
                  <a:moveTo>
                    <a:pt x="0" y="0"/>
                  </a:moveTo>
                  <a:lnTo>
                    <a:pt x="61" y="0"/>
                  </a:lnTo>
                  <a:lnTo>
                    <a:pt x="61" y="559"/>
                  </a:lnTo>
                  <a:lnTo>
                    <a:pt x="0" y="559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703520" y="2957400"/>
              <a:ext cx="102960" cy="10447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2154240" y="3656160"/>
              <a:ext cx="96840" cy="345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703520" y="2957400"/>
              <a:ext cx="102960" cy="1044720"/>
            </a:xfrm>
            <a:custGeom>
              <a:avLst/>
              <a:gdLst/>
              <a:ahLst/>
              <a:rect l="l" t="t" r="r" b="b"/>
              <a:pathLst>
                <a:path w="65" h="658">
                  <a:moveTo>
                    <a:pt x="0" y="0"/>
                  </a:moveTo>
                  <a:lnTo>
                    <a:pt x="65" y="0"/>
                  </a:lnTo>
                  <a:lnTo>
                    <a:pt x="65" y="658"/>
                  </a:lnTo>
                  <a:lnTo>
                    <a:pt x="0" y="65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2154240" y="3656160"/>
              <a:ext cx="96840" cy="345960"/>
            </a:xfrm>
            <a:custGeom>
              <a:avLst/>
              <a:gdLst/>
              <a:ahLst/>
              <a:rect l="l" t="t" r="r" b="b"/>
              <a:pathLst>
                <a:path w="61" h="218">
                  <a:moveTo>
                    <a:pt x="0" y="0"/>
                  </a:moveTo>
                  <a:lnTo>
                    <a:pt x="61" y="0"/>
                  </a:lnTo>
                  <a:lnTo>
                    <a:pt x="61" y="218"/>
                  </a:lnTo>
                  <a:lnTo>
                    <a:pt x="0" y="21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2598840" y="3516480"/>
              <a:ext cx="102960" cy="4856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911160" y="2938320"/>
              <a:ext cx="96840" cy="1063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2598840" y="3516480"/>
              <a:ext cx="102960" cy="485640"/>
            </a:xfrm>
            <a:custGeom>
              <a:avLst/>
              <a:gdLst/>
              <a:ahLst/>
              <a:rect l="l" t="t" r="r" b="b"/>
              <a:pathLst>
                <a:path w="65" h="306">
                  <a:moveTo>
                    <a:pt x="0" y="0"/>
                  </a:moveTo>
                  <a:lnTo>
                    <a:pt x="65" y="0"/>
                  </a:lnTo>
                  <a:lnTo>
                    <a:pt x="65" y="306"/>
                  </a:lnTo>
                  <a:lnTo>
                    <a:pt x="0" y="30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911160" y="2938320"/>
              <a:ext cx="96840" cy="1063800"/>
            </a:xfrm>
            <a:custGeom>
              <a:avLst/>
              <a:gdLst/>
              <a:ahLst/>
              <a:rect l="l" t="t" r="r" b="b"/>
              <a:pathLst>
                <a:path w="61" h="670">
                  <a:moveTo>
                    <a:pt x="0" y="0"/>
                  </a:moveTo>
                  <a:lnTo>
                    <a:pt x="61" y="0"/>
                  </a:lnTo>
                  <a:lnTo>
                    <a:pt x="61" y="670"/>
                  </a:lnTo>
                  <a:lnTo>
                    <a:pt x="0" y="67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355760" y="2817720"/>
              <a:ext cx="98280" cy="1184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806480" y="3193920"/>
              <a:ext cx="96840" cy="808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1355760" y="2817720"/>
              <a:ext cx="98280" cy="1184400"/>
            </a:xfrm>
            <a:custGeom>
              <a:avLst/>
              <a:gdLst/>
              <a:ahLst/>
              <a:rect l="l" t="t" r="r" b="b"/>
              <a:pathLst>
                <a:path w="62" h="746">
                  <a:moveTo>
                    <a:pt x="0" y="0"/>
                  </a:moveTo>
                  <a:lnTo>
                    <a:pt x="62" y="0"/>
                  </a:lnTo>
                  <a:lnTo>
                    <a:pt x="62" y="746"/>
                  </a:lnTo>
                  <a:lnTo>
                    <a:pt x="0" y="74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806480" y="3193920"/>
              <a:ext cx="96840" cy="808200"/>
            </a:xfrm>
            <a:custGeom>
              <a:avLst/>
              <a:gdLst/>
              <a:ahLst/>
              <a:rect l="l" t="t" r="r" b="b"/>
              <a:pathLst>
                <a:path w="61" h="509">
                  <a:moveTo>
                    <a:pt x="0" y="0"/>
                  </a:moveTo>
                  <a:lnTo>
                    <a:pt x="61" y="0"/>
                  </a:lnTo>
                  <a:lnTo>
                    <a:pt x="61" y="509"/>
                  </a:lnTo>
                  <a:lnTo>
                    <a:pt x="0" y="509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2251080" y="3703680"/>
              <a:ext cx="98280" cy="298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2701800" y="3825720"/>
              <a:ext cx="98640" cy="176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2251080" y="3703680"/>
              <a:ext cx="98280" cy="298440"/>
            </a:xfrm>
            <a:custGeom>
              <a:avLst/>
              <a:gdLst/>
              <a:ahLst/>
              <a:rect l="l" t="t" r="r" b="b"/>
              <a:pathLst>
                <a:path w="62" h="188">
                  <a:moveTo>
                    <a:pt x="0" y="0"/>
                  </a:moveTo>
                  <a:lnTo>
                    <a:pt x="62" y="0"/>
                  </a:lnTo>
                  <a:lnTo>
                    <a:pt x="62" y="188"/>
                  </a:lnTo>
                  <a:lnTo>
                    <a:pt x="0" y="18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2701800" y="3825720"/>
              <a:ext cx="98640" cy="176400"/>
            </a:xfrm>
            <a:custGeom>
              <a:avLst/>
              <a:gdLst/>
              <a:ahLst/>
              <a:rect l="l" t="t" r="r" b="b"/>
              <a:pathLst>
                <a:path w="62" h="111">
                  <a:moveTo>
                    <a:pt x="0" y="0"/>
                  </a:moveTo>
                  <a:lnTo>
                    <a:pt x="62" y="0"/>
                  </a:lnTo>
                  <a:lnTo>
                    <a:pt x="62" y="111"/>
                  </a:lnTo>
                  <a:lnTo>
                    <a:pt x="0" y="11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1008000" y="2938320"/>
              <a:ext cx="98640" cy="1063800"/>
            </a:xfrm>
            <a:prstGeom prst="rect">
              <a:avLst/>
            </a:prstGeom>
            <a:solidFill>
              <a:srgbClr val="dd080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454040" y="2744640"/>
              <a:ext cx="103320" cy="1257480"/>
            </a:xfrm>
            <a:prstGeom prst="rect">
              <a:avLst/>
            </a:prstGeom>
            <a:solidFill>
              <a:srgbClr val="dd080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008000" y="2938320"/>
              <a:ext cx="98640" cy="1063800"/>
            </a:xfrm>
            <a:custGeom>
              <a:avLst/>
              <a:gdLst/>
              <a:ahLst/>
              <a:rect l="l" t="t" r="r" b="b"/>
              <a:pathLst>
                <a:path w="62" h="670">
                  <a:moveTo>
                    <a:pt x="0" y="0"/>
                  </a:moveTo>
                  <a:lnTo>
                    <a:pt x="62" y="0"/>
                  </a:lnTo>
                  <a:lnTo>
                    <a:pt x="62" y="670"/>
                  </a:lnTo>
                  <a:lnTo>
                    <a:pt x="0" y="67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454040" y="2744640"/>
              <a:ext cx="103320" cy="1257480"/>
            </a:xfrm>
            <a:custGeom>
              <a:avLst/>
              <a:gdLst/>
              <a:ahLst/>
              <a:rect l="l" t="t" r="r" b="b"/>
              <a:pathLst>
                <a:path w="65" h="792">
                  <a:moveTo>
                    <a:pt x="0" y="0"/>
                  </a:moveTo>
                  <a:lnTo>
                    <a:pt x="65" y="0"/>
                  </a:lnTo>
                  <a:lnTo>
                    <a:pt x="65" y="792"/>
                  </a:lnTo>
                  <a:lnTo>
                    <a:pt x="0" y="792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903320" y="3424320"/>
              <a:ext cx="98640" cy="577800"/>
            </a:xfrm>
            <a:prstGeom prst="rect">
              <a:avLst/>
            </a:prstGeom>
            <a:solidFill>
              <a:srgbClr val="dd080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2349360" y="3656160"/>
              <a:ext cx="103320" cy="345960"/>
            </a:xfrm>
            <a:prstGeom prst="rect">
              <a:avLst/>
            </a:prstGeom>
            <a:solidFill>
              <a:srgbClr val="dd080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903320" y="3424320"/>
              <a:ext cx="98640" cy="577800"/>
            </a:xfrm>
            <a:custGeom>
              <a:avLst/>
              <a:gdLst/>
              <a:ahLst/>
              <a:rect l="l" t="t" r="r" b="b"/>
              <a:pathLst>
                <a:path w="62" h="364">
                  <a:moveTo>
                    <a:pt x="0" y="0"/>
                  </a:moveTo>
                  <a:lnTo>
                    <a:pt x="62" y="0"/>
                  </a:lnTo>
                  <a:lnTo>
                    <a:pt x="62" y="364"/>
                  </a:lnTo>
                  <a:lnTo>
                    <a:pt x="0" y="364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2349360" y="3656160"/>
              <a:ext cx="103320" cy="345960"/>
            </a:xfrm>
            <a:custGeom>
              <a:avLst/>
              <a:gdLst/>
              <a:ahLst/>
              <a:rect l="l" t="t" r="r" b="b"/>
              <a:pathLst>
                <a:path w="65" h="218">
                  <a:moveTo>
                    <a:pt x="0" y="0"/>
                  </a:moveTo>
                  <a:lnTo>
                    <a:pt x="65" y="0"/>
                  </a:lnTo>
                  <a:lnTo>
                    <a:pt x="65" y="218"/>
                  </a:lnTo>
                  <a:lnTo>
                    <a:pt x="0" y="218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2800440" y="3733920"/>
              <a:ext cx="96840" cy="268200"/>
            </a:xfrm>
            <a:prstGeom prst="rect">
              <a:avLst/>
            </a:prstGeom>
            <a:solidFill>
              <a:srgbClr val="dd0806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2800440" y="3733920"/>
              <a:ext cx="96840" cy="268200"/>
            </a:xfrm>
            <a:custGeom>
              <a:avLst/>
              <a:gdLst/>
              <a:ahLst/>
              <a:rect l="l" t="t" r="r" b="b"/>
              <a:pathLst>
                <a:path w="61" h="169">
                  <a:moveTo>
                    <a:pt x="0" y="0"/>
                  </a:moveTo>
                  <a:lnTo>
                    <a:pt x="61" y="0"/>
                  </a:lnTo>
                  <a:lnTo>
                    <a:pt x="61" y="169"/>
                  </a:lnTo>
                  <a:lnTo>
                    <a:pt x="0" y="169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flipV="1">
              <a:off x="731880" y="2185560"/>
              <a:ext cx="1440" cy="1816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709560" y="3703680"/>
              <a:ext cx="12600" cy="1440"/>
            </a:xfrm>
            <a:custGeom>
              <a:avLst/>
              <a:gdLst/>
              <a:ahLst/>
              <a:rect l="l" t="t" r="r" b="b"/>
              <a:pathLst>
                <a:path w="8" h="0">
                  <a:moveTo>
                    <a:pt x="0" y="0"/>
                  </a:moveTo>
                  <a:lnTo>
                    <a:pt x="8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flipH="1">
              <a:off x="723960" y="4002120"/>
              <a:ext cx="79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709560" y="3097080"/>
              <a:ext cx="12600" cy="1800"/>
            </a:xfrm>
            <a:custGeom>
              <a:avLst/>
              <a:gdLst/>
              <a:ahLst/>
              <a:rect l="l" t="t" r="r" b="b"/>
              <a:pathLst>
                <a:path w="8" h="0">
                  <a:moveTo>
                    <a:pt x="0" y="0"/>
                  </a:moveTo>
                  <a:lnTo>
                    <a:pt x="8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flipH="1">
              <a:off x="714240" y="3394080"/>
              <a:ext cx="7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 flipH="1">
              <a:off x="709560" y="3097080"/>
              <a:ext cx="79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709560" y="2792520"/>
              <a:ext cx="12600" cy="1440"/>
            </a:xfrm>
            <a:custGeom>
              <a:avLst/>
              <a:gdLst/>
              <a:ahLst/>
              <a:rect l="l" t="t" r="r" b="b"/>
              <a:pathLst>
                <a:path w="8" h="0">
                  <a:moveTo>
                    <a:pt x="0" y="0"/>
                  </a:moveTo>
                  <a:lnTo>
                    <a:pt x="8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709560" y="2495520"/>
              <a:ext cx="12600" cy="1440"/>
            </a:xfrm>
            <a:custGeom>
              <a:avLst/>
              <a:gdLst/>
              <a:ahLst/>
              <a:rect l="l" t="t" r="r" b="b"/>
              <a:pathLst>
                <a:path w="8" h="0">
                  <a:moveTo>
                    <a:pt x="0" y="0"/>
                  </a:moveTo>
                  <a:lnTo>
                    <a:pt x="8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 flipH="1">
              <a:off x="709560" y="2792520"/>
              <a:ext cx="7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709560" y="2192400"/>
              <a:ext cx="12600" cy="1440"/>
            </a:xfrm>
            <a:custGeom>
              <a:avLst/>
              <a:gdLst/>
              <a:ahLst/>
              <a:rect l="l" t="t" r="r" b="b"/>
              <a:pathLst>
                <a:path w="8" h="0">
                  <a:moveTo>
                    <a:pt x="0" y="0"/>
                  </a:moveTo>
                  <a:lnTo>
                    <a:pt x="8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d0806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 flipH="1">
              <a:off x="731880" y="4002120"/>
              <a:ext cx="2241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731880" y="40021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1182600" y="40021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2077920" y="4030560"/>
              <a:ext cx="1800" cy="17640"/>
            </a:xfrm>
            <a:custGeom>
              <a:avLst/>
              <a:gdLst/>
              <a:ahLst/>
              <a:rect l="l" t="t" r="r" b="b"/>
              <a:pathLst>
                <a:path w="0" h="11">
                  <a:moveTo>
                    <a:pt x="0" y="11"/>
                  </a:moveTo>
                  <a:lnTo>
                    <a:pt x="0" y="0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1627200" y="4002120"/>
              <a:ext cx="144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2077920" y="40021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2523960" y="40021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973240" y="4002120"/>
              <a:ext cx="1800" cy="11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3" name=""/>
            <p:cNvGrpSpPr/>
            <p:nvPr/>
          </p:nvGrpSpPr>
          <p:grpSpPr>
            <a:xfrm>
              <a:off x="591840" y="2154240"/>
              <a:ext cx="107280" cy="1914120"/>
              <a:chOff x="591840" y="2154240"/>
              <a:chExt cx="107280" cy="1914120"/>
            </a:xfrm>
          </p:grpSpPr>
          <p:sp>
            <p:nvSpPr>
              <p:cNvPr id="374" name=""/>
              <p:cNvSpPr/>
              <p:nvPr/>
            </p:nvSpPr>
            <p:spPr>
              <a:xfrm>
                <a:off x="655200" y="39765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591840" y="365904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655200" y="336060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591840" y="305892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655200" y="275724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591840" y="246348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655200" y="215424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81" name=""/>
            <p:cNvSpPr/>
            <p:nvPr/>
          </p:nvSpPr>
          <p:spPr>
            <a:xfrm>
              <a:off x="722520" y="2322360"/>
              <a:ext cx="1201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B49.5 (Chr4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1503000" y="2127240"/>
              <a:ext cx="64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flipH="1" flipV="1">
              <a:off x="342720" y="3068280"/>
              <a:ext cx="4680" cy="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rot="16200000">
              <a:off x="-99360" y="2943720"/>
              <a:ext cx="113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% signal/% DA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85" name=""/>
          <p:cNvGrpSpPr/>
          <p:nvPr/>
        </p:nvGrpSpPr>
        <p:grpSpPr>
          <a:xfrm>
            <a:off x="582120" y="4100400"/>
            <a:ext cx="2391120" cy="2143800"/>
            <a:chOff x="582120" y="4100400"/>
            <a:chExt cx="2391120" cy="2143800"/>
          </a:xfrm>
        </p:grpSpPr>
        <p:sp>
          <p:nvSpPr>
            <p:cNvPr id="386" name=""/>
            <p:cNvSpPr/>
            <p:nvPr/>
          </p:nvSpPr>
          <p:spPr>
            <a:xfrm>
              <a:off x="723960" y="4268880"/>
              <a:ext cx="140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J21.C3 (Chr11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87" name=""/>
            <p:cNvGrpSpPr/>
            <p:nvPr/>
          </p:nvGrpSpPr>
          <p:grpSpPr>
            <a:xfrm>
              <a:off x="933120" y="5989680"/>
              <a:ext cx="1834200" cy="91800"/>
              <a:chOff x="933120" y="5989680"/>
              <a:chExt cx="1834200" cy="91800"/>
            </a:xfrm>
          </p:grpSpPr>
          <p:sp>
            <p:nvSpPr>
              <p:cNvPr id="388" name=""/>
              <p:cNvSpPr/>
              <p:nvPr/>
            </p:nvSpPr>
            <p:spPr>
              <a:xfrm>
                <a:off x="933120" y="59896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1377720" y="59896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1828440" y="59896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2274480" y="59896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2723760" y="59896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93" name=""/>
            <p:cNvGrpSpPr/>
            <p:nvPr/>
          </p:nvGrpSpPr>
          <p:grpSpPr>
            <a:xfrm>
              <a:off x="714240" y="4160880"/>
              <a:ext cx="2257560" cy="1802880"/>
              <a:chOff x="714240" y="4160880"/>
              <a:chExt cx="2257560" cy="1802880"/>
            </a:xfrm>
          </p:grpSpPr>
          <p:sp>
            <p:nvSpPr>
              <p:cNvPr id="394" name=""/>
              <p:cNvSpPr/>
              <p:nvPr/>
            </p:nvSpPr>
            <p:spPr>
              <a:xfrm>
                <a:off x="900000" y="5761800"/>
                <a:ext cx="7920" cy="2019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80172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1349280" y="5823360"/>
                <a:ext cx="7920" cy="1404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125100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1798560" y="5387400"/>
                <a:ext cx="7920" cy="5760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170028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2247840" y="5322960"/>
                <a:ext cx="7920" cy="64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214956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2697120" y="4919760"/>
                <a:ext cx="7920" cy="10440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259884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996840" y="5149800"/>
                <a:ext cx="7920" cy="8139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901800" y="5960520"/>
                <a:ext cx="10296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1446120" y="5397480"/>
                <a:ext cx="9720" cy="5662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1351080" y="5960520"/>
                <a:ext cx="10476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1895400" y="5212800"/>
                <a:ext cx="9720" cy="7509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1800360" y="5960520"/>
                <a:ext cx="10476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2346480" y="5470200"/>
                <a:ext cx="7920" cy="493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2249640" y="5960520"/>
                <a:ext cx="10476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2795760" y="5466960"/>
                <a:ext cx="7920" cy="496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2700360" y="5960520"/>
                <a:ext cx="10332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1098720" y="5047560"/>
                <a:ext cx="7920" cy="9162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1000080" y="5960520"/>
                <a:ext cx="10656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1547640" y="5466960"/>
                <a:ext cx="8280" cy="496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1449360" y="5960520"/>
                <a:ext cx="10656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1996920" y="5442480"/>
                <a:ext cx="7920" cy="5212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189864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2446200" y="5271120"/>
                <a:ext cx="7920" cy="6926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234792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2895480" y="5466960"/>
                <a:ext cx="7920" cy="496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2797200" y="5960520"/>
                <a:ext cx="106200" cy="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798480" y="5758200"/>
                <a:ext cx="101520" cy="2019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1247760" y="5820120"/>
                <a:ext cx="101520" cy="1404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1697040" y="5384520"/>
                <a:ext cx="101520" cy="57564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2146320" y="5318280"/>
                <a:ext cx="101520" cy="64224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2595600" y="4916520"/>
                <a:ext cx="101520" cy="104400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900000" y="5146560"/>
                <a:ext cx="96840" cy="81396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1349280" y="5394240"/>
                <a:ext cx="96840" cy="56628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1798560" y="5209560"/>
                <a:ext cx="96840" cy="75096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2247840" y="5466960"/>
                <a:ext cx="98640" cy="49356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2697120" y="5464080"/>
                <a:ext cx="98640" cy="496440"/>
              </a:xfrm>
              <a:prstGeom prst="rect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996840" y="5044320"/>
                <a:ext cx="101880" cy="916200"/>
              </a:xfrm>
              <a:prstGeom prst="rect">
                <a:avLst/>
              </a:prstGeom>
              <a:solidFill>
                <a:srgbClr val="dd0806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1446120" y="5464080"/>
                <a:ext cx="101520" cy="496440"/>
              </a:xfrm>
              <a:prstGeom prst="rect">
                <a:avLst/>
              </a:prstGeom>
              <a:solidFill>
                <a:srgbClr val="dd0806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1895400" y="5439240"/>
                <a:ext cx="101520" cy="521280"/>
              </a:xfrm>
              <a:prstGeom prst="rect">
                <a:avLst/>
              </a:prstGeom>
              <a:solidFill>
                <a:srgbClr val="dd0806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2346480" y="5267880"/>
                <a:ext cx="99720" cy="692640"/>
              </a:xfrm>
              <a:prstGeom prst="rect">
                <a:avLst/>
              </a:prstGeom>
              <a:solidFill>
                <a:srgbClr val="dd0806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2795760" y="5464080"/>
                <a:ext cx="99720" cy="496440"/>
              </a:xfrm>
              <a:prstGeom prst="rect">
                <a:avLst/>
              </a:prstGeom>
              <a:solidFill>
                <a:srgbClr val="dd0806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>
                <a:off x="725400" y="4160880"/>
                <a:ext cx="1800" cy="1799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714240" y="5960520"/>
                <a:ext cx="111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714240" y="5662800"/>
                <a:ext cx="11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714240" y="5360040"/>
                <a:ext cx="111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>
                <a:off x="714240" y="5060880"/>
                <a:ext cx="11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>
                <a:off x="714240" y="4762800"/>
                <a:ext cx="111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>
                <a:off x="714240" y="4460400"/>
                <a:ext cx="11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>
                <a:off x="714240" y="4160880"/>
                <a:ext cx="11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>
                <a:off x="725400" y="5960520"/>
                <a:ext cx="224640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48" name=""/>
            <p:cNvSpPr/>
            <p:nvPr/>
          </p:nvSpPr>
          <p:spPr>
            <a:xfrm flipV="1">
              <a:off x="725400" y="5960880"/>
              <a:ext cx="180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 flipV="1">
              <a:off x="1174680" y="5960880"/>
              <a:ext cx="180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 flipV="1">
              <a:off x="1623960" y="5960880"/>
              <a:ext cx="180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 flipV="1">
              <a:off x="2073240" y="5960880"/>
              <a:ext cx="180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 flipV="1">
              <a:off x="2522520" y="5960880"/>
              <a:ext cx="144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 flipV="1">
              <a:off x="2971800" y="5960880"/>
              <a:ext cx="1440" cy="14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4" name=""/>
            <p:cNvGrpSpPr/>
            <p:nvPr/>
          </p:nvGrpSpPr>
          <p:grpSpPr>
            <a:xfrm>
              <a:off x="582120" y="4100400"/>
              <a:ext cx="107280" cy="1914120"/>
              <a:chOff x="582120" y="4100400"/>
              <a:chExt cx="107280" cy="1914120"/>
            </a:xfrm>
          </p:grpSpPr>
          <p:sp>
            <p:nvSpPr>
              <p:cNvPr id="455" name=""/>
              <p:cNvSpPr/>
              <p:nvPr/>
            </p:nvSpPr>
            <p:spPr>
              <a:xfrm>
                <a:off x="645480" y="592272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>
                <a:off x="582120" y="560520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>
                <a:off x="645480" y="53067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>
                <a:off x="582120" y="500508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>
                <a:off x="645480" y="470340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>
                <a:off x="582120" y="440964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>
                <a:off x="645480" y="410040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2" name=""/>
            <p:cNvSpPr/>
            <p:nvPr/>
          </p:nvSpPr>
          <p:spPr>
            <a:xfrm>
              <a:off x="760320" y="6043680"/>
              <a:ext cx="37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edg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2518200" y="6043680"/>
              <a:ext cx="424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</a:rPr>
                <a:t>centr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1160640" y="6141960"/>
              <a:ext cx="1271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08T15:02:54Z</dcterms:created>
  <dc:creator>Office 2004 Test Drive User</dc:creator>
  <dc:description/>
  <dc:language>en-US</dc:language>
  <cp:lastModifiedBy>Office 2004 Test Drive User</cp:lastModifiedBy>
  <dcterms:modified xsi:type="dcterms:W3CDTF">2008-02-21T11:40:22Z</dcterms:modified>
  <cp:revision>35</cp:revision>
  <dc:subject/>
  <dc:title>PowerPoint Presentation</dc:title>
</cp:coreProperties>
</file>